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9" d="100"/>
          <a:sy n="79" d="100"/>
        </p:scale>
        <p:origin x="1570" y="120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95" name="Google Shape;95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1"/>
          <p:cNvSpPr txBox="1"/>
          <p:nvPr/>
        </p:nvSpPr>
        <p:spPr>
          <a:xfrm>
            <a:off x="-109976" y="2067123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1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nuscript Title </a:t>
            </a:r>
            <a:endParaRPr sz="12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 txBox="1"/>
          <p:nvPr/>
        </p:nvSpPr>
        <p:spPr>
          <a:xfrm>
            <a:off x="7664524" y="515085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9" name="Google Shape;99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67849" y="3815738"/>
            <a:ext cx="2808368" cy="778106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Google Shape;100;p1"/>
          <p:cNvSpPr/>
          <p:nvPr/>
        </p:nvSpPr>
        <p:spPr>
          <a:xfrm>
            <a:off x="-47888" y="1549155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01" name="Google Shape;101;p1"/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/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                       @ThoraxBMJ</a:t>
              </a:r>
              <a:endParaRPr sz="1725" b="1" i="0" u="none" strike="noStrike" cap="none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/>
          <p:cNvSpPr/>
          <p:nvPr/>
        </p:nvSpPr>
        <p:spPr>
          <a:xfrm>
            <a:off x="0" y="288328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156079" y="323765"/>
            <a:ext cx="10358195" cy="623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US" sz="1575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Inflammation in preschool cystic fibrosis is of mixed phenotype, extends beyond the lung, </a:t>
            </a: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US" sz="1575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and is differentially modified by CFTR modulators</a:t>
            </a:r>
          </a:p>
        </p:txBody>
      </p:sp>
      <p:sp>
        <p:nvSpPr>
          <p:cNvPr id="106" name="Google Shape;106;p1"/>
          <p:cNvSpPr txBox="1"/>
          <p:nvPr/>
        </p:nvSpPr>
        <p:spPr>
          <a:xfrm>
            <a:off x="38565" y="1724959"/>
            <a:ext cx="90980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9" name="Google Shape;109;p1" descr="About Twitter | Our logo, brand guidelines, and Tweet tools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8ABF43A9-F0A1-A4F3-1985-FD84F1A2DB3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12153" y="2366090"/>
            <a:ext cx="2781022" cy="3111829"/>
          </a:xfrm>
          <a:prstGeom prst="rect">
            <a:avLst/>
          </a:prstGeom>
        </p:spPr>
      </p:pic>
      <p:sp>
        <p:nvSpPr>
          <p:cNvPr id="3" name="Google Shape;105;p1">
            <a:extLst>
              <a:ext uri="{FF2B5EF4-FFF2-40B4-BE49-F238E27FC236}">
                <a16:creationId xmlns:a16="http://schemas.microsoft.com/office/drawing/2014/main" id="{68F2F33A-D287-7955-5436-B807C4A4E0D5}"/>
              </a:ext>
            </a:extLst>
          </p:cNvPr>
          <p:cNvSpPr txBox="1"/>
          <p:nvPr/>
        </p:nvSpPr>
        <p:spPr>
          <a:xfrm>
            <a:off x="5691312" y="1742903"/>
            <a:ext cx="3557877" cy="623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US" sz="1575" b="1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Inflammation is </a:t>
            </a:r>
            <a:r>
              <a:rPr lang="en-US" sz="1575" b="1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partially resolved by ivacaftor but not lumacaftor/ivacaftor</a:t>
            </a:r>
          </a:p>
        </p:txBody>
      </p:sp>
      <p:sp>
        <p:nvSpPr>
          <p:cNvPr id="4" name="Google Shape;105;p1">
            <a:extLst>
              <a:ext uri="{FF2B5EF4-FFF2-40B4-BE49-F238E27FC236}">
                <a16:creationId xmlns:a16="http://schemas.microsoft.com/office/drawing/2014/main" id="{BD38CD50-6F10-4BB3-4E92-5D215C88AB7B}"/>
              </a:ext>
            </a:extLst>
          </p:cNvPr>
          <p:cNvSpPr txBox="1"/>
          <p:nvPr/>
        </p:nvSpPr>
        <p:spPr>
          <a:xfrm>
            <a:off x="2072277" y="1756262"/>
            <a:ext cx="3741194" cy="623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US" sz="1575" b="1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Marked cellular and soluble inflammation </a:t>
            </a: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US" sz="1575" b="1" i="0" u="none" strike="noStrike" cap="none" dirty="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in early life CF airways and bloo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4D46C33-90E5-8513-B74D-5F8EA34BC7B5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r="38836"/>
          <a:stretch/>
        </p:blipFill>
        <p:spPr>
          <a:xfrm>
            <a:off x="2161561" y="2322254"/>
            <a:ext cx="2338855" cy="149348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5DC0D9D-6D15-E5D7-56B5-CE9B8E4EEEC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211984" y="3746743"/>
            <a:ext cx="2268123" cy="185357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85ADC73-5170-60DB-0022-D61769BCC8AA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62022" t="20104" r="-3037" b="31601"/>
          <a:stretch/>
        </p:blipFill>
        <p:spPr>
          <a:xfrm>
            <a:off x="4589276" y="2385904"/>
            <a:ext cx="1265722" cy="582093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38CAF082-E663-39A5-35D9-0796B71D3C3B}"/>
              </a:ext>
            </a:extLst>
          </p:cNvPr>
          <p:cNvSpPr/>
          <p:nvPr/>
        </p:nvSpPr>
        <p:spPr>
          <a:xfrm>
            <a:off x="2133237" y="1737126"/>
            <a:ext cx="3609854" cy="38463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0AD0B2C-B7BE-C0FE-FE34-4F4DB6D54D61}"/>
              </a:ext>
            </a:extLst>
          </p:cNvPr>
          <p:cNvSpPr/>
          <p:nvPr/>
        </p:nvSpPr>
        <p:spPr>
          <a:xfrm>
            <a:off x="5820112" y="1737127"/>
            <a:ext cx="3270125" cy="3846300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10" name="Picture 9" descr="A close-up of a computer screen&#10;&#10;Description automatically generated">
            <a:extLst>
              <a:ext uri="{FF2B5EF4-FFF2-40B4-BE49-F238E27FC236}">
                <a16:creationId xmlns:a16="http://schemas.microsoft.com/office/drawing/2014/main" id="{166395E6-BCF8-D454-3388-51D62488E8BB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45" t="7889" r="53000" b="70208"/>
          <a:stretch/>
        </p:blipFill>
        <p:spPr>
          <a:xfrm>
            <a:off x="894775" y="3370158"/>
            <a:ext cx="1057136" cy="644696"/>
          </a:xfrm>
          <a:prstGeom prst="rect">
            <a:avLst/>
          </a:prstGeom>
        </p:spPr>
      </p:pic>
      <p:pic>
        <p:nvPicPr>
          <p:cNvPr id="11" name="Picture 10" descr="A screenshot of a computer&#10;&#10;Description automatically generated">
            <a:extLst>
              <a:ext uri="{FF2B5EF4-FFF2-40B4-BE49-F238E27FC236}">
                <a16:creationId xmlns:a16="http://schemas.microsoft.com/office/drawing/2014/main" id="{7C688915-3603-2482-6576-8389F9C3D7AD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97" t="60867" r="75135" b="25097"/>
          <a:stretch/>
        </p:blipFill>
        <p:spPr>
          <a:xfrm>
            <a:off x="7367" y="3133725"/>
            <a:ext cx="624359" cy="708683"/>
          </a:xfrm>
          <a:prstGeom prst="rect">
            <a:avLst/>
          </a:prstGeom>
        </p:spPr>
      </p:pic>
      <p:pic>
        <p:nvPicPr>
          <p:cNvPr id="12" name="Picture 11" descr="A screenshot of a computer&#10;&#10;Description automatically generated">
            <a:extLst>
              <a:ext uri="{FF2B5EF4-FFF2-40B4-BE49-F238E27FC236}">
                <a16:creationId xmlns:a16="http://schemas.microsoft.com/office/drawing/2014/main" id="{96017DB0-7CD1-D60B-83C3-83640EDD7564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43" t="56459" r="49408" b="25097"/>
          <a:stretch/>
        </p:blipFill>
        <p:spPr>
          <a:xfrm>
            <a:off x="696563" y="2867201"/>
            <a:ext cx="1321143" cy="555859"/>
          </a:xfrm>
          <a:prstGeom prst="rect">
            <a:avLst/>
          </a:prstGeom>
        </p:spPr>
      </p:pic>
      <p:pic>
        <p:nvPicPr>
          <p:cNvPr id="13" name="Picture 12" descr="A close-up of a chart&#10;&#10;Description automatically generated">
            <a:extLst>
              <a:ext uri="{FF2B5EF4-FFF2-40B4-BE49-F238E27FC236}">
                <a16:creationId xmlns:a16="http://schemas.microsoft.com/office/drawing/2014/main" id="{E4EB5D6A-6867-A2F3-E0B9-80CFAAFBB217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50" t="62735" r="74639" b="15385"/>
          <a:stretch/>
        </p:blipFill>
        <p:spPr>
          <a:xfrm>
            <a:off x="318823" y="4994435"/>
            <a:ext cx="501411" cy="690524"/>
          </a:xfrm>
          <a:prstGeom prst="rect">
            <a:avLst/>
          </a:prstGeom>
        </p:spPr>
      </p:pic>
      <p:pic>
        <p:nvPicPr>
          <p:cNvPr id="14" name="Picture 13" descr="A close-up of several icons&#10;&#10;Description automatically generated">
            <a:extLst>
              <a:ext uri="{FF2B5EF4-FFF2-40B4-BE49-F238E27FC236}">
                <a16:creationId xmlns:a16="http://schemas.microsoft.com/office/drawing/2014/main" id="{BB0C9135-697F-0A74-1774-463E6DC4AF12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4" t="53227" r="95089" b="36207"/>
          <a:stretch/>
        </p:blipFill>
        <p:spPr>
          <a:xfrm>
            <a:off x="177057" y="1788535"/>
            <a:ext cx="282305" cy="521721"/>
          </a:xfrm>
          <a:prstGeom prst="rect">
            <a:avLst/>
          </a:prstGeom>
        </p:spPr>
      </p:pic>
      <p:pic>
        <p:nvPicPr>
          <p:cNvPr id="16" name="Picture 15" descr="A close-up of several icons&#10;&#10;Description automatically generated">
            <a:extLst>
              <a:ext uri="{FF2B5EF4-FFF2-40B4-BE49-F238E27FC236}">
                <a16:creationId xmlns:a16="http://schemas.microsoft.com/office/drawing/2014/main" id="{EEC515DD-04FA-99CF-7687-3BAD534EA774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3" t="75906" r="94793" b="13263"/>
          <a:stretch/>
        </p:blipFill>
        <p:spPr>
          <a:xfrm>
            <a:off x="88263" y="2202621"/>
            <a:ext cx="386830" cy="534858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EBC33B4-BCA8-27FC-C0A9-4C7EF1138288}"/>
              </a:ext>
            </a:extLst>
          </p:cNvPr>
          <p:cNvSpPr txBox="1"/>
          <p:nvPr/>
        </p:nvSpPr>
        <p:spPr>
          <a:xfrm>
            <a:off x="466002" y="1818941"/>
            <a:ext cx="122247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100" dirty="0"/>
              <a:t>Preschool CF (n=70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DAB2B2C-3ED2-F484-2C15-8CF037677CED}"/>
              </a:ext>
            </a:extLst>
          </p:cNvPr>
          <p:cNvSpPr txBox="1"/>
          <p:nvPr/>
        </p:nvSpPr>
        <p:spPr>
          <a:xfrm>
            <a:off x="437634" y="2306854"/>
            <a:ext cx="126677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dirty="0"/>
              <a:t>Preschool Control (n=32)</a:t>
            </a:r>
          </a:p>
        </p:txBody>
      </p:sp>
      <p:pic>
        <p:nvPicPr>
          <p:cNvPr id="22" name="Picture 21" descr="A close-up of a computer screen&#10;&#10;Description automatically generated">
            <a:extLst>
              <a:ext uri="{FF2B5EF4-FFF2-40B4-BE49-F238E27FC236}">
                <a16:creationId xmlns:a16="http://schemas.microsoft.com/office/drawing/2014/main" id="{EAD67AD4-85C7-96E0-9AC6-878C539CD7CE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 l="47997" t="11353" r="36776" b="65854"/>
          <a:stretch/>
        </p:blipFill>
        <p:spPr>
          <a:xfrm>
            <a:off x="88263" y="4006510"/>
            <a:ext cx="935018" cy="652996"/>
          </a:xfrm>
          <a:prstGeom prst="rect">
            <a:avLst/>
          </a:prstGeom>
        </p:spPr>
      </p:pic>
      <p:pic>
        <p:nvPicPr>
          <p:cNvPr id="23" name="Picture 22" descr="A close-up of a computer screen&#10;&#10;Description automatically generated">
            <a:extLst>
              <a:ext uri="{FF2B5EF4-FFF2-40B4-BE49-F238E27FC236}">
                <a16:creationId xmlns:a16="http://schemas.microsoft.com/office/drawing/2014/main" id="{8E327ADD-A465-2EF0-F766-09CE909F75B5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45" t="7889" r="53000" b="70208"/>
          <a:stretch/>
        </p:blipFill>
        <p:spPr>
          <a:xfrm>
            <a:off x="915834" y="4850451"/>
            <a:ext cx="1005045" cy="612928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8D89D2C9-5C6D-C582-F95A-DEC8633C3E5F}"/>
              </a:ext>
            </a:extLst>
          </p:cNvPr>
          <p:cNvSpPr txBox="1"/>
          <p:nvPr/>
        </p:nvSpPr>
        <p:spPr>
          <a:xfrm>
            <a:off x="177057" y="2963883"/>
            <a:ext cx="10719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b="1" dirty="0"/>
              <a:t>BA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7935FCF-6D80-8121-55BF-1E07EC78C410}"/>
              </a:ext>
            </a:extLst>
          </p:cNvPr>
          <p:cNvSpPr txBox="1"/>
          <p:nvPr/>
        </p:nvSpPr>
        <p:spPr>
          <a:xfrm>
            <a:off x="150766" y="4726890"/>
            <a:ext cx="10719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50" b="1" dirty="0"/>
              <a:t>PLASMA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5DF844CB-0A74-9D4B-2113-CA8044E64426}"/>
              </a:ext>
            </a:extLst>
          </p:cNvPr>
          <p:cNvSpPr/>
          <p:nvPr/>
        </p:nvSpPr>
        <p:spPr>
          <a:xfrm>
            <a:off x="53792" y="1737126"/>
            <a:ext cx="2013035" cy="1040819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2DAF4B43-A3EE-AA10-215D-1467930135A8}"/>
              </a:ext>
            </a:extLst>
          </p:cNvPr>
          <p:cNvSpPr/>
          <p:nvPr/>
        </p:nvSpPr>
        <p:spPr>
          <a:xfrm>
            <a:off x="53792" y="2824842"/>
            <a:ext cx="2013035" cy="1820197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FDA5F19C-DA3A-A9E1-2C30-5038421D898C}"/>
              </a:ext>
            </a:extLst>
          </p:cNvPr>
          <p:cNvSpPr/>
          <p:nvPr/>
        </p:nvSpPr>
        <p:spPr>
          <a:xfrm>
            <a:off x="53792" y="4721539"/>
            <a:ext cx="2013035" cy="861888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" name="Google Shape;105;p1">
            <a:extLst>
              <a:ext uri="{FF2B5EF4-FFF2-40B4-BE49-F238E27FC236}">
                <a16:creationId xmlns:a16="http://schemas.microsoft.com/office/drawing/2014/main" id="{89E31D6E-2716-7A2A-E6C7-02E6419F3F2C}"/>
              </a:ext>
            </a:extLst>
          </p:cNvPr>
          <p:cNvSpPr txBox="1"/>
          <p:nvPr/>
        </p:nvSpPr>
        <p:spPr>
          <a:xfrm>
            <a:off x="150766" y="1100760"/>
            <a:ext cx="10358195" cy="35388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US" i="0" u="none" strike="noStrike" cap="none" dirty="0">
                <a:solidFill>
                  <a:schemeClr val="tx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Shanthikumar S, et al. Thorax 2025. DOI:</a:t>
            </a:r>
            <a:r>
              <a:rPr lang="en-AU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10.1136/thorax-2025-221634</a:t>
            </a:r>
            <a:endParaRPr lang="en-US" i="0" u="none" strike="noStrike" cap="none" dirty="0">
              <a:solidFill>
                <a:schemeClr val="tx1"/>
              </a:solidFill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109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olantonio</dc:creator>
  <cp:lastModifiedBy>Melanie Neeland</cp:lastModifiedBy>
  <cp:revision>10</cp:revision>
  <dcterms:created xsi:type="dcterms:W3CDTF">2018-02-16T17:34:16Z</dcterms:created>
  <dcterms:modified xsi:type="dcterms:W3CDTF">2025-01-13T07:29:48Z</dcterms:modified>
</cp:coreProperties>
</file>